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charts/chart1.xml" ContentType="application/vnd.openxmlformats-officedocument.drawingml.char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7772400" cy="100584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n-US"/>
  <c:roundedCorners val="0"/>
  <c:chart>
    <c:autoTitleDeleted val="1"/>
    <c:plotArea>
      <c:barChart>
        <c:barDir val="col"/>
        <c:grouping val="clustered"/>
        <c:varyColors val="0"/>
        <c:ser>
          <c:idx val="0"/>
          <c:order val="0"/>
          <c:spPr>
            <a:solidFill>
              <a:srgbClr val="5b9bd5"/>
            </a:solidFill>
            <a:ln w="0">
              <a:noFill/>
            </a:ln>
          </c:spPr>
          <c:invertIfNegative val="0"/>
          <c:cat>
            <c:strRef>
              <c:f>categories</c:f>
              <c:strCache>
                <c:ptCount val="0"/>
              </c:strCache>
            </c:strRef>
          </c:cat>
        </c:ser>
        <c:gapWidth val="219"/>
        <c:overlap val="-27"/>
        <c:axId val="14301052"/>
        <c:axId val="33604323"/>
      </c:barChart>
      <c:catAx>
        <c:axId val="14301052"/>
        <c:scaling>
          <c:orientation val="minMax"/>
        </c:scaling>
        <c:delete val="0"/>
        <c:axPos val="b"/>
        <c:numFmt formatCode="[$-409]mm/dd/yyyy" sourceLinked="1"/>
        <c:majorTickMark val="none"/>
        <c:minorTickMark val="none"/>
        <c:tickLblPos val="nextTo"/>
        <c:spPr>
          <a:ln w="19080">
            <a:solidFill>
              <a:srgbClr val="000000"/>
            </a:solidFill>
            <a:round/>
          </a:ln>
        </c:spPr>
        <c:txPr>
          <a:bodyPr rot="4800000"/>
          <a:lstStyle/>
          <a:p>
            <a:pPr>
              <a:defRPr b="0" sz="1800" spc="-1" strike="noStrike">
                <a:solidFill>
                  <a:srgbClr val="000000"/>
                </a:solidFill>
                <a:latin typeface="Times New Roman"/>
              </a:defRPr>
            </a:pPr>
          </a:p>
        </c:txPr>
        <c:crossAx val="33604323"/>
        <c:crosses val="autoZero"/>
        <c:auto val="1"/>
        <c:lblAlgn val="ctr"/>
        <c:lblOffset val="100"/>
        <c:noMultiLvlLbl val="0"/>
      </c:catAx>
      <c:valAx>
        <c:axId val="33604323"/>
        <c:scaling>
          <c:orientation val="minMax"/>
        </c:scaling>
        <c:delete val="0"/>
        <c:axPos val="l"/>
        <c:title>
          <c:tx>
            <c:rich>
              <a:bodyPr rot="-5400000"/>
              <a:lstStyle/>
              <a:p>
                <a:pPr>
                  <a:defRPr b="0" sz="1800" spc="-1" strike="noStrike">
                    <a:solidFill>
                      <a:srgbClr val="000000"/>
                    </a:solidFill>
                    <a:latin typeface="Times New Roman"/>
                  </a:defRPr>
                </a:pPr>
                <a:r>
                  <a:rPr b="0" sz="1800" spc="-1" strike="noStrike">
                    <a:solidFill>
                      <a:srgbClr val="000000"/>
                    </a:solidFill>
                    <a:latin typeface="Times New Roman"/>
                  </a:rPr>
                  <a:t>SNCV (m/s)</a:t>
                </a:r>
              </a:p>
            </c:rich>
          </c:tx>
          <c:layout>
            <c:manualLayout>
              <c:xMode val="edge"/>
              <c:yMode val="edge"/>
              <c:x val="0.00540649790308726"/>
              <c:y val="0.370888632429313"/>
            </c:manualLayout>
          </c:layout>
          <c:overlay val="0"/>
          <c:spPr>
            <a:noFill/>
            <a:ln w="0">
              <a:noFill/>
            </a:ln>
          </c:spPr>
        </c:title>
        <c:numFmt formatCode="General" sourceLinked="1"/>
        <c:majorTickMark val="in"/>
        <c:minorTickMark val="none"/>
        <c:tickLblPos val="nextTo"/>
        <c:spPr>
          <a:ln w="19080">
            <a:solidFill>
              <a:srgbClr val="000000"/>
            </a:solidFill>
            <a:round/>
          </a:ln>
        </c:spPr>
        <c:txPr>
          <a:bodyPr rot="4800000"/>
          <a:lstStyle/>
          <a:p>
            <a:pPr>
              <a:defRPr b="0" sz="1800" spc="-1" strike="noStrike">
                <a:solidFill>
                  <a:srgbClr val="000000"/>
                </a:solidFill>
                <a:latin typeface="Times New Roman"/>
              </a:defRPr>
            </a:pPr>
          </a:p>
        </c:txPr>
        <c:crossAx val="14301052"/>
        <c:crosses val="autoZero"/>
        <c:crossBetween val="between"/>
      </c:valAx>
      <c:spPr>
        <a:noFill/>
        <a:ln w="0">
          <a:noFill/>
        </a:ln>
      </c:spPr>
    </c:plotArea>
    <c:plotVisOnly val="1"/>
    <c:dispBlanksAs val="gap"/>
  </c:chart>
  <c:spPr>
    <a:solidFill>
      <a:srgbClr val="ffffff"/>
    </a:solidFill>
    <a:ln w="9360">
      <a:noFill/>
    </a:ln>
  </c:spPr>
</c:chartSpace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7E35F7C2-FEC1-4FEA-8B13-3F20D7E76537}" type="slidenum">
              <a:t>&lt;#&gt;</a:t>
            </a:fld>
          </a:p>
        </p:txBody>
      </p:sp>
      <p:sp>
        <p:nvSpPr>
          <p:cNvPr id="3" name="PlaceHolder 2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2520"/>
            <a:ext cx="8228160" cy="1143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lnSpc>
                <a:spcPct val="92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4880"/>
            <a:ext cx="8228160" cy="215784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8280"/>
            <a:ext cx="8228160" cy="215784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70542528-A5E1-4E2B-A0D1-261CABC7444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2520"/>
            <a:ext cx="8228160" cy="1143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lnSpc>
                <a:spcPct val="92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4880"/>
            <a:ext cx="4015080" cy="215784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3520" y="1604880"/>
            <a:ext cx="4015080" cy="215784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8280"/>
            <a:ext cx="4015080" cy="215784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3520" y="3968280"/>
            <a:ext cx="4015080" cy="215784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F2D276B9-690E-4A7D-95F4-9CEAD72424B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2520"/>
            <a:ext cx="8228160" cy="1143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lnSpc>
                <a:spcPct val="92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4880"/>
            <a:ext cx="2649240" cy="215784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280" y="1604880"/>
            <a:ext cx="2649240" cy="215784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1360" y="1604880"/>
            <a:ext cx="2649240" cy="215784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8280"/>
            <a:ext cx="2649240" cy="215784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280" y="3968280"/>
            <a:ext cx="2649240" cy="215784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1360" y="3968280"/>
            <a:ext cx="2649240" cy="215784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9D07065F-438F-4E56-B714-4141A59B0861}" type="slidenum">
              <a:t>&lt;#&gt;</a:t>
            </a:fld>
          </a:p>
        </p:txBody>
      </p:sp>
      <p:sp>
        <p:nvSpPr>
          <p:cNvPr id="10" name="PlaceHolder 9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2520"/>
            <a:ext cx="8228160" cy="1143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lnSpc>
                <a:spcPct val="92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4880"/>
            <a:ext cx="8228160" cy="45244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marL="343080" indent="0" algn="ctr">
              <a:lnSpc>
                <a:spcPct val="93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616F1944-B0CB-4763-B5E5-C4886A3E6B3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2520"/>
            <a:ext cx="8228160" cy="1143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lnSpc>
                <a:spcPct val="92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4880"/>
            <a:ext cx="8228160" cy="452448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3CC5D80E-C28A-4F46-845F-7947F10ECB2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2520"/>
            <a:ext cx="8228160" cy="1143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lnSpc>
                <a:spcPct val="92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4880"/>
            <a:ext cx="4015080" cy="452448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3520" y="1604880"/>
            <a:ext cx="4015080" cy="452448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636E300B-3AD5-4A52-BA80-2A03917E754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2520"/>
            <a:ext cx="8228160" cy="1143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lnSpc>
                <a:spcPct val="92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E6D998F1-3F4D-464D-83CC-D235754FD845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2520"/>
            <a:ext cx="822816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marL="343080" indent="-343080" algn="ctr"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A0554FD9-4125-4DE3-9CEF-9EA52E0C3424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2520"/>
            <a:ext cx="8228160" cy="1143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lnSpc>
                <a:spcPct val="92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4880"/>
            <a:ext cx="4015080" cy="215784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3520" y="1604880"/>
            <a:ext cx="4015080" cy="452448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8280"/>
            <a:ext cx="4015080" cy="215784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14C382D6-D8A0-474D-8978-120DFA92716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2520"/>
            <a:ext cx="8228160" cy="1143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lnSpc>
                <a:spcPct val="92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4880"/>
            <a:ext cx="4015080" cy="452448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3520" y="1604880"/>
            <a:ext cx="4015080" cy="215784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3520" y="3968280"/>
            <a:ext cx="4015080" cy="215784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E9718F5A-AD6E-4797-99E6-711C17CE6ED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2520"/>
            <a:ext cx="8228160" cy="1143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lnSpc>
                <a:spcPct val="92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4880"/>
            <a:ext cx="4015080" cy="215784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3520" y="1604880"/>
            <a:ext cx="4015080" cy="215784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8280"/>
            <a:ext cx="8228160" cy="215784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8FA5CB39-AD46-4517-B8CC-66187A27E23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dt" idx="1"/>
          </p:nvPr>
        </p:nvSpPr>
        <p:spPr>
          <a:xfrm>
            <a:off x="628200" y="6356160"/>
            <a:ext cx="2055960" cy="363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5000" bIns="45000" anchor="t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723960"/>
                <a:tab algn="l" pos="144792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  <a:defRPr b="0" lang="en-US" sz="1800" spc="-1" strike="noStrike">
                <a:solidFill>
                  <a:srgbClr val="000000"/>
                </a:solidFill>
                <a:latin typeface="Calibri"/>
                <a:ea typeface="Arial Unicode MS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723960"/>
                <a:tab algn="l" pos="144792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  <a:ea typeface="Arial Unicode MS"/>
              </a:rPr>
              <a:t>9/15/16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"/>
          <p:cNvSpPr/>
          <p:nvPr/>
        </p:nvSpPr>
        <p:spPr>
          <a:xfrm>
            <a:off x="3029040" y="6356520"/>
            <a:ext cx="3085920" cy="365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2"/>
          <p:cNvSpPr>
            <a:spLocks noGrp="1"/>
          </p:cNvSpPr>
          <p:nvPr>
            <p:ph type="sldNum" idx="2"/>
          </p:nvPr>
        </p:nvSpPr>
        <p:spPr>
          <a:xfrm>
            <a:off x="6458040" y="6356160"/>
            <a:ext cx="2055600" cy="363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5000" bIns="45000" anchor="t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723960"/>
                <a:tab algn="l" pos="144792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  <a:defRPr b="0" lang="en-US" sz="1800" spc="-1" strike="noStrike">
                <a:solidFill>
                  <a:srgbClr val="000000"/>
                </a:solidFill>
                <a:latin typeface="Calibri"/>
                <a:ea typeface="Arial Unicode MS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723960"/>
                <a:tab algn="l" pos="144792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fld id="{1EA219D9-DE59-47CF-9CEE-DD71630BF4AD}" type="slidenum">
              <a:rPr b="0" lang="en-US" sz="1800" spc="-1" strike="noStrike">
                <a:solidFill>
                  <a:srgbClr val="000000"/>
                </a:solidFill>
                <a:latin typeface="Calibri"/>
                <a:ea typeface="Arial Unicode MS"/>
              </a:rPr>
              <a:t>&lt;number&gt;</a:t>
            </a:fld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3"/>
          <p:cNvSpPr>
            <a:spLocks noGrp="1"/>
          </p:cNvSpPr>
          <p:nvPr>
            <p:ph type="title"/>
          </p:nvPr>
        </p:nvSpPr>
        <p:spPr>
          <a:xfrm>
            <a:off x="457200" y="272520"/>
            <a:ext cx="8228160" cy="1143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lnSpc>
                <a:spcPct val="92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4"/>
          <p:cNvSpPr>
            <a:spLocks noGrp="1"/>
          </p:cNvSpPr>
          <p:nvPr>
            <p:ph type="body"/>
          </p:nvPr>
        </p:nvSpPr>
        <p:spPr>
          <a:xfrm>
            <a:off x="457200" y="1604880"/>
            <a:ext cx="8228160" cy="452448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2000"/>
              </a:lnSpc>
              <a:spcAft>
                <a:spcPts val="1426"/>
              </a:spcAft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1" marL="343080" indent="-343080">
              <a:lnSpc>
                <a:spcPct val="92000"/>
              </a:lnSpc>
              <a:spcAft>
                <a:spcPts val="1426"/>
              </a:spcAft>
              <a:buClr>
                <a:srgbClr val="000000"/>
              </a:buClr>
              <a:buFont typeface="Times New Roman"/>
              <a:buChar char="–"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2" marL="343080" indent="-343080">
              <a:lnSpc>
                <a:spcPct val="92000"/>
              </a:lnSpc>
              <a:spcAft>
                <a:spcPts val="1426"/>
              </a:spcAft>
              <a:buClr>
                <a:srgbClr val="000000"/>
              </a:buClr>
              <a:buFont typeface="Times New Roman"/>
              <a:buChar char="•"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3" marL="343080" indent="-343080">
              <a:lnSpc>
                <a:spcPct val="92000"/>
              </a:lnSpc>
              <a:spcAft>
                <a:spcPts val="1426"/>
              </a:spcAft>
              <a:buClr>
                <a:srgbClr val="000000"/>
              </a:buClr>
              <a:buFont typeface="Times New Roman"/>
              <a:buChar char="–"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4" marL="343080" indent="-343080">
              <a:lnSpc>
                <a:spcPct val="92000"/>
              </a:lnSpc>
              <a:spcAft>
                <a:spcPts val="1426"/>
              </a:spcAft>
              <a:buClr>
                <a:srgbClr val="000000"/>
              </a:buClr>
              <a:buFont typeface="Times New Roman"/>
              <a:buChar char="»"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5" marL="343080" indent="-343080">
              <a:lnSpc>
                <a:spcPct val="92000"/>
              </a:lnSpc>
              <a:spcAft>
                <a:spcPts val="1426"/>
              </a:spcAft>
              <a:buClr>
                <a:srgbClr val="000000"/>
              </a:buClr>
              <a:buFont typeface="Times New Roman"/>
              <a:buChar char="»"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6" marL="343080" indent="-343080">
              <a:lnSpc>
                <a:spcPct val="92000"/>
              </a:lnSpc>
              <a:spcAft>
                <a:spcPts val="1426"/>
              </a:spcAft>
              <a:buClr>
                <a:srgbClr val="000000"/>
              </a:buClr>
              <a:buFont typeface="Times New Roman"/>
              <a:buChar char="»"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chart" Target="../charts/chart1.xml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1" name=""/>
          <p:cNvGraphicFramePr/>
          <p:nvPr/>
        </p:nvGraphicFramePr>
        <p:xfrm>
          <a:off x="927000" y="469800"/>
          <a:ext cx="7124760" cy="499104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"/>
          </a:graphicData>
        </a:graphic>
      </p:graphicFrame>
      <p:sp>
        <p:nvSpPr>
          <p:cNvPr id="42" name=""/>
          <p:cNvSpPr/>
          <p:nvPr/>
        </p:nvSpPr>
        <p:spPr>
          <a:xfrm>
            <a:off x="330120" y="5791320"/>
            <a:ext cx="8661600" cy="913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t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723960"/>
                <a:tab algn="l" pos="1447920"/>
                <a:tab algn="l" pos="2171880"/>
                <a:tab algn="l" pos="2895480"/>
                <a:tab algn="l" pos="3619440"/>
                <a:tab algn="l" pos="4343400"/>
                <a:tab algn="l" pos="5067360"/>
                <a:tab algn="l" pos="5791320"/>
                <a:tab algn="l" pos="6515280"/>
                <a:tab algn="l" pos="7238880"/>
                <a:tab algn="l" pos="796284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Times New Roman"/>
              </a:rPr>
              <a:t>Additional file 2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algn="just">
              <a:lnSpc>
                <a:spcPct val="100000"/>
              </a:lnSpc>
              <a:tabLst>
                <a:tab algn="l" pos="0"/>
                <a:tab algn="l" pos="723960"/>
                <a:tab algn="l" pos="1447920"/>
                <a:tab algn="l" pos="2171880"/>
                <a:tab algn="l" pos="2895480"/>
                <a:tab algn="l" pos="3619440"/>
                <a:tab algn="l" pos="4343400"/>
                <a:tab algn="l" pos="5067360"/>
                <a:tab algn="l" pos="5791320"/>
                <a:tab algn="l" pos="6515280"/>
                <a:tab algn="l" pos="7238880"/>
                <a:tab algn="l" pos="796284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Influence of CDDP dosing times on SNCV after the fourth administration of CDDP to rats on day 27.  Each value represents the mean with S.E.M. (n = 7- 10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creator/>
  <dc:description/>
  <dc:language>en-US</dc:language>
  <cp:lastModifiedBy/>
  <cp:revision>0</cp:revision>
  <dc:subject/>
  <dc:title/>
</cp:coreProperties>
</file>